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3" d="100"/>
          <a:sy n="103" d="100"/>
        </p:scale>
        <p:origin x="82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D04419-AEE3-4E0D-B16B-A1BDD0249FC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2D3FD93-48DA-4A62-AD0C-3969C7263C6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4283A0-01A2-4174-A30A-531E758234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A78EF-F8E1-4067-BDD1-554F54EA9E91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39F3CA-BEDB-4161-86A6-7506FD10FF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41CBF5-370F-4A4A-8D5A-C1BA82687E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8A445-5EE2-492D-9DF8-48F286AD0F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075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BDDEE9-10F8-4275-8F46-E85E008F65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4DA73E-E3CE-43C2-B444-1AAB25E997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F30887-4C96-4185-B63F-7853F68615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A78EF-F8E1-4067-BDD1-554F54EA9E91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646055-FE8D-49A7-AB70-91D99F2734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0700C3-349E-4EB6-829B-7BC39F50EF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8A445-5EE2-492D-9DF8-48F286AD0F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81127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2430E96-AD79-447D-9B25-CC6D3E06E25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6E8BEFF-FC9C-4045-B88B-E9EBF813F1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D3436A-99E2-4CD2-8BA7-521F36F7AD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A78EF-F8E1-4067-BDD1-554F54EA9E91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CB5F55-6C0E-4EC8-A2C9-2958C66F5E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922D35-AB59-41AC-8EBE-AEDC443CDE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8A445-5EE2-492D-9DF8-48F286AD0F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8260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A166EB-35C3-4179-A95D-0047463646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4BAFB8-6E12-45A9-BBB4-A8B1CB5419B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A1E9A3-9E50-42F8-AD1B-8138577D71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A78EF-F8E1-4067-BDD1-554F54EA9E91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3FE8D5-BD9F-483A-844F-F7B1226F93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F44A08-2494-4BA0-AAB4-C13E2D2516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8A445-5EE2-492D-9DF8-48F286AD0F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43496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650DEE-CF56-4887-AE39-37BDCFFF09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7387B1D-A8E7-494F-967C-3E229CC3B4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1AABDD-E0B9-4C63-82AC-ED60828B76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A78EF-F8E1-4067-BDD1-554F54EA9E91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1B1268-3F64-49BB-A7D3-88D7B5394A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C2C934-BE62-4D2B-B115-CFF376A26D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8A445-5EE2-492D-9DF8-48F286AD0F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1495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B749E2-D87F-4A69-BB2F-159A273D00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D73FF7-6ADC-4F70-8FA9-457C564D105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682EB18-BF9B-456D-A8D1-E4C3763EF7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C7EC311-5BEF-41CD-B21F-2190474DD3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A78EF-F8E1-4067-BDD1-554F54EA9E91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F89B21-AF3F-41CC-B34B-54AE639FC9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69DD820-905D-4BD9-8BF0-2AF26CD736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8A445-5EE2-492D-9DF8-48F286AD0F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99944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E9EDE0-B15D-4AEB-91DA-0CC05F7C4B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6A8CF4-CF6A-4BB9-B768-5DFF9CC413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2163D4-CC77-4DA8-8F7D-3F91D61529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044BA2F-51EB-4D12-A9F7-D3F074DF1A0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A356BEE-0428-4DDE-8AAE-87E3533DD96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A1BA512-3B99-46BA-B9F3-A94C497A81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A78EF-F8E1-4067-BDD1-554F54EA9E91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252F116-3714-44B5-9825-2F215190A0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AA9333A-3C4F-4867-A821-D3019741E1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8A445-5EE2-492D-9DF8-48F286AD0F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33626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5C7842-7F96-409F-9E4A-3FC4944D82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56F0FEC-345F-4850-9812-719F8EB0A3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A78EF-F8E1-4067-BDD1-554F54EA9E91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A0741B6-BF55-46E0-ABFE-F02F5A27F1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3BD16E0-30F4-4A48-B2FB-1AD206F691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8A445-5EE2-492D-9DF8-48F286AD0F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9628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926EE5C-7A69-48AC-B007-43031FD944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A78EF-F8E1-4067-BDD1-554F54EA9E91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74A7907-9F30-43A6-8259-822E1EDE13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E0E70D1-97BC-4DD3-9751-C9BBAF67D9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8A445-5EE2-492D-9DF8-48F286AD0F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24630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7C092B-117E-4D3E-8846-A9E35EFE59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5BA20D-20F1-4B47-9E64-1DDD03BC4B5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2D3631E-6CEF-4E21-8C9E-EEA86618B9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7E89B61-B399-40EF-A473-CCA4763083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A78EF-F8E1-4067-BDD1-554F54EA9E91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B47DFBF-5F3D-487F-AE4E-CC0AA7CFEC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3CC9426-DC6B-4476-BDAF-B102B6F6F7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8A445-5EE2-492D-9DF8-48F286AD0F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76128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AAE4A9-B295-4335-BA49-1C24EC3E21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1195C06-66B8-421A-A453-D15F227CB2C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FD441EE-D6F3-4563-AD23-03371C746D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314317-2BF4-4FAC-BBEB-91EC5026E6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DA78EF-F8E1-4067-BDD1-554F54EA9E91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993EDDB-4FD9-4D25-819C-03B0C0E472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D35A21-E7C1-47F9-8AF9-76E155A6B7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8A445-5EE2-492D-9DF8-48F286AD0F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02843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9F98653-1860-4DCA-A7A2-84CEC22193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377774A-04BA-4BEF-9E63-0D20536022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C12B09-6B4E-4FCE-9042-C341331D93E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DA78EF-F8E1-4067-BDD1-554F54EA9E91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6CEABB-565B-4B09-A0F7-88D7791383E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C830D5-73CE-4B53-B9A7-FFDBC0F425A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98A445-5EE2-492D-9DF8-48F286AD0F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0123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77D08544-D1DA-4D3E-B642-A6D415E33B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Supplementary Figure S1</a:t>
            </a:r>
            <a:r>
              <a:rPr lang="en-US" dirty="0"/>
              <a:t>: Clinical trials by year and Phase</a:t>
            </a:r>
          </a:p>
        </p:txBody>
      </p:sp>
      <p:pic>
        <p:nvPicPr>
          <p:cNvPr id="7" name="Content Placeholder 6">
            <a:extLst>
              <a:ext uri="{FF2B5EF4-FFF2-40B4-BE49-F238E27FC236}">
                <a16:creationId xmlns:a16="http://schemas.microsoft.com/office/drawing/2014/main" id="{ACD58F16-D1F2-414D-A4E2-E9568D15BE57}"/>
              </a:ext>
            </a:extLst>
          </p:cNvPr>
          <p:cNvPicPr>
            <a:picLocks noGrp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72492" y="2126774"/>
            <a:ext cx="6247015" cy="374904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6110664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EE2320-5C1A-4EFD-BD59-D59921AFFD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ry Figure S2: Clinical Trials by Year and Intervention</a:t>
            </a:r>
          </a:p>
        </p:txBody>
      </p:sp>
      <p:pic>
        <p:nvPicPr>
          <p:cNvPr id="6" name="Content Placeholder 5">
            <a:extLst>
              <a:ext uri="{FF2B5EF4-FFF2-40B4-BE49-F238E27FC236}">
                <a16:creationId xmlns:a16="http://schemas.microsoft.com/office/drawing/2014/main" id="{50C0FFB5-8D9D-4115-965C-6EC698A97CBB}"/>
              </a:ext>
            </a:extLst>
          </p:cNvPr>
          <p:cNvPicPr>
            <a:picLocks noGrp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07822" y="2147556"/>
            <a:ext cx="6176356" cy="3707476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7191875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0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Supplementary Figure S1: Clinical trials by year and Phase</vt:lpstr>
      <vt:lpstr>Supplementary Figure S2: Clinical Trials by Year and Interven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 Figure 1: Clinical trials by year and Phase</dc:title>
  <dc:creator>Jonathan Metts</dc:creator>
  <cp:lastModifiedBy>MDPI</cp:lastModifiedBy>
  <cp:revision>3</cp:revision>
  <dcterms:created xsi:type="dcterms:W3CDTF">2023-04-04T15:40:29Z</dcterms:created>
  <dcterms:modified xsi:type="dcterms:W3CDTF">2026-03-26T12:31:00Z</dcterms:modified>
</cp:coreProperties>
</file>